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65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EBE1C779-1A9A-4B75-8FCF-B9A788BED485}"/>
    <pc:docChg chg="addSld modSld">
      <pc:chgData name="Tekle Pauzaite" userId="06f7e524-8501-4f81-9b2a-484f6f2c7061" providerId="ADAL" clId="{EBE1C779-1A9A-4B75-8FCF-B9A788BED485}" dt="2024-03-27T08:33:22.652" v="154" actId="571"/>
      <pc:docMkLst>
        <pc:docMk/>
      </pc:docMkLst>
      <pc:sldChg chg="addSp delSp modSp add">
        <pc:chgData name="Tekle Pauzaite" userId="06f7e524-8501-4f81-9b2a-484f6f2c7061" providerId="ADAL" clId="{EBE1C779-1A9A-4B75-8FCF-B9A788BED485}" dt="2024-03-27T08:33:22.652" v="154" actId="571"/>
        <pc:sldMkLst>
          <pc:docMk/>
          <pc:sldMk cId="1632868039" sldId="256"/>
        </pc:sldMkLst>
        <pc:spChg chg="del">
          <ac:chgData name="Tekle Pauzaite" userId="06f7e524-8501-4f81-9b2a-484f6f2c7061" providerId="ADAL" clId="{EBE1C779-1A9A-4B75-8FCF-B9A788BED485}" dt="2024-03-27T08:28:32.357" v="1"/>
          <ac:spMkLst>
            <pc:docMk/>
            <pc:sldMk cId="1632868039" sldId="256"/>
            <ac:spMk id="2" creationId="{1AD2B526-41E0-43E2-A32E-6DE1B14CD754}"/>
          </ac:spMkLst>
        </pc:spChg>
        <pc:spChg chg="del">
          <ac:chgData name="Tekle Pauzaite" userId="06f7e524-8501-4f81-9b2a-484f6f2c7061" providerId="ADAL" clId="{EBE1C779-1A9A-4B75-8FCF-B9A788BED485}" dt="2024-03-27T08:28:32.357" v="1"/>
          <ac:spMkLst>
            <pc:docMk/>
            <pc:sldMk cId="1632868039" sldId="256"/>
            <ac:spMk id="3" creationId="{C4DAD2EB-10A6-4BFE-91ED-0BBE558A0D4D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8" creationId="{3F3D270A-980A-4203-8193-EB80322C8C4D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9" creationId="{026C3111-BB47-4A68-B086-17C8971BBCBB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0" creationId="{AC68886A-46AF-4EF6-89EC-13AB869E2DD6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2" creationId="{F82DD0FB-1D3F-4FDB-B64A-1DDD42B08CBD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4" creationId="{4C310176-72F2-4E04-BE9D-BF305B40E334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6" creationId="{10367B89-794E-4D87-A454-F5DE3FCF6CFD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7" creationId="{FC7FBF1D-5109-4DCF-9225-39DD5293A0CB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8" creationId="{B84D7696-B38E-42BB-8311-EAA213306EF8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19" creationId="{7A401C27-2E21-4429-8F77-89D9E17B0D44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1" creationId="{83609F11-7ABD-439F-A17F-F07B837A7355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3" creationId="{3C04188A-320F-4CE9-8743-9C74906EFD0C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4" creationId="{78B06F9D-81AE-4B47-9372-1C67A1465A0D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5" creationId="{64011465-6E14-46EB-A409-091BF4C9415F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6" creationId="{02F764B9-1094-42F5-84AA-0C3AA1EDE949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7" creationId="{37B2B951-41F4-4722-818E-D059C1244D92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8" creationId="{DBE07845-B0F1-4BF8-A45F-A169AD0402D6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29" creationId="{F446AF7A-A132-4852-8550-A467E8A4A384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32" creationId="{243F1AC9-995B-4D5D-B356-C56CF34E085B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33" creationId="{F9861E2F-6EB2-43AB-A800-5D3E1BB69709}"/>
          </ac:spMkLst>
        </pc:spChg>
        <pc:spChg chg="add mod">
          <ac:chgData name="Tekle Pauzaite" userId="06f7e524-8501-4f81-9b2a-484f6f2c7061" providerId="ADAL" clId="{EBE1C779-1A9A-4B75-8FCF-B9A788BED485}" dt="2024-03-27T08:28:42.828" v="4" actId="1076"/>
          <ac:spMkLst>
            <pc:docMk/>
            <pc:sldMk cId="1632868039" sldId="256"/>
            <ac:spMk id="34" creationId="{EA5E5A4B-343F-4F23-9AE5-EF668683AC27}"/>
          </ac:spMkLst>
        </pc:spChg>
        <pc:spChg chg="add mod">
          <ac:chgData name="Tekle Pauzaite" userId="06f7e524-8501-4f81-9b2a-484f6f2c7061" providerId="ADAL" clId="{EBE1C779-1A9A-4B75-8FCF-B9A788BED485}" dt="2024-03-27T08:30:47.810" v="73" actId="1036"/>
          <ac:spMkLst>
            <pc:docMk/>
            <pc:sldMk cId="1632868039" sldId="256"/>
            <ac:spMk id="37" creationId="{DE552C32-B466-4C33-B8FF-E07D3446BFB0}"/>
          </ac:spMkLst>
        </pc:spChg>
        <pc:spChg chg="add mod">
          <ac:chgData name="Tekle Pauzaite" userId="06f7e524-8501-4f81-9b2a-484f6f2c7061" providerId="ADAL" clId="{EBE1C779-1A9A-4B75-8FCF-B9A788BED485}" dt="2024-03-27T08:31:08.526" v="92" actId="14100"/>
          <ac:spMkLst>
            <pc:docMk/>
            <pc:sldMk cId="1632868039" sldId="256"/>
            <ac:spMk id="39" creationId="{7EEBCB5F-58BE-45F8-A3F3-9CF883B23EEB}"/>
          </ac:spMkLst>
        </pc:spChg>
        <pc:spChg chg="add mod">
          <ac:chgData name="Tekle Pauzaite" userId="06f7e524-8501-4f81-9b2a-484f6f2c7061" providerId="ADAL" clId="{EBE1C779-1A9A-4B75-8FCF-B9A788BED485}" dt="2024-03-27T08:31:51.403" v="109" actId="1076"/>
          <ac:spMkLst>
            <pc:docMk/>
            <pc:sldMk cId="1632868039" sldId="256"/>
            <ac:spMk id="41" creationId="{88611FE3-3DFC-434B-A100-6D2AA6B84E02}"/>
          </ac:spMkLst>
        </pc:spChg>
        <pc:spChg chg="add mod">
          <ac:chgData name="Tekle Pauzaite" userId="06f7e524-8501-4f81-9b2a-484f6f2c7061" providerId="ADAL" clId="{EBE1C779-1A9A-4B75-8FCF-B9A788BED485}" dt="2024-03-27T08:32:19.179" v="125" actId="1076"/>
          <ac:spMkLst>
            <pc:docMk/>
            <pc:sldMk cId="1632868039" sldId="256"/>
            <ac:spMk id="43" creationId="{EFB77EA1-F51F-4876-AC46-ED5E6BBA6D88}"/>
          </ac:spMkLst>
        </pc:spChg>
        <pc:spChg chg="add mod">
          <ac:chgData name="Tekle Pauzaite" userId="06f7e524-8501-4f81-9b2a-484f6f2c7061" providerId="ADAL" clId="{EBE1C779-1A9A-4B75-8FCF-B9A788BED485}" dt="2024-03-27T08:33:01.631" v="149" actId="1038"/>
          <ac:spMkLst>
            <pc:docMk/>
            <pc:sldMk cId="1632868039" sldId="256"/>
            <ac:spMk id="45" creationId="{0D0C5E06-7EFF-4C71-8CCF-DFA00E097F5E}"/>
          </ac:spMkLst>
        </pc:spChg>
        <pc:spChg chg="add mod">
          <ac:chgData name="Tekle Pauzaite" userId="06f7e524-8501-4f81-9b2a-484f6f2c7061" providerId="ADAL" clId="{EBE1C779-1A9A-4B75-8FCF-B9A788BED485}" dt="2024-03-27T08:33:07.912" v="150" actId="571"/>
          <ac:spMkLst>
            <pc:docMk/>
            <pc:sldMk cId="1632868039" sldId="256"/>
            <ac:spMk id="46" creationId="{1C6206A9-AA02-4FEB-8EE0-4B24975E8ED0}"/>
          </ac:spMkLst>
        </pc:spChg>
        <pc:spChg chg="add mod">
          <ac:chgData name="Tekle Pauzaite" userId="06f7e524-8501-4f81-9b2a-484f6f2c7061" providerId="ADAL" clId="{EBE1C779-1A9A-4B75-8FCF-B9A788BED485}" dt="2024-03-27T08:33:11.948" v="151" actId="571"/>
          <ac:spMkLst>
            <pc:docMk/>
            <pc:sldMk cId="1632868039" sldId="256"/>
            <ac:spMk id="47" creationId="{11D95358-D4F1-4BB3-B7F9-DC3D0030FBC6}"/>
          </ac:spMkLst>
        </pc:spChg>
        <pc:spChg chg="add mod">
          <ac:chgData name="Tekle Pauzaite" userId="06f7e524-8501-4f81-9b2a-484f6f2c7061" providerId="ADAL" clId="{EBE1C779-1A9A-4B75-8FCF-B9A788BED485}" dt="2024-03-27T08:33:15.388" v="152" actId="571"/>
          <ac:spMkLst>
            <pc:docMk/>
            <pc:sldMk cId="1632868039" sldId="256"/>
            <ac:spMk id="48" creationId="{2E405721-94ED-494E-AB5D-89B6426B3CDB}"/>
          </ac:spMkLst>
        </pc:spChg>
        <pc:spChg chg="add mod">
          <ac:chgData name="Tekle Pauzaite" userId="06f7e524-8501-4f81-9b2a-484f6f2c7061" providerId="ADAL" clId="{EBE1C779-1A9A-4B75-8FCF-B9A788BED485}" dt="2024-03-27T08:33:19.516" v="153" actId="571"/>
          <ac:spMkLst>
            <pc:docMk/>
            <pc:sldMk cId="1632868039" sldId="256"/>
            <ac:spMk id="49" creationId="{299B85F9-D6CB-4FA7-A4A1-7CC804FC9BD5}"/>
          </ac:spMkLst>
        </pc:spChg>
        <pc:spChg chg="add mod">
          <ac:chgData name="Tekle Pauzaite" userId="06f7e524-8501-4f81-9b2a-484f6f2c7061" providerId="ADAL" clId="{EBE1C779-1A9A-4B75-8FCF-B9A788BED485}" dt="2024-03-27T08:33:22.652" v="154" actId="571"/>
          <ac:spMkLst>
            <pc:docMk/>
            <pc:sldMk cId="1632868039" sldId="256"/>
            <ac:spMk id="50" creationId="{B36E4465-1351-4A22-94FD-DC0FECE635C7}"/>
          </ac:spMkLst>
        </pc:spChg>
        <pc:picChg chg="add mod">
          <ac:chgData name="Tekle Pauzaite" userId="06f7e524-8501-4f81-9b2a-484f6f2c7061" providerId="ADAL" clId="{EBE1C779-1A9A-4B75-8FCF-B9A788BED485}" dt="2024-03-27T08:28:42.828" v="4" actId="1076"/>
          <ac:picMkLst>
            <pc:docMk/>
            <pc:sldMk cId="1632868039" sldId="256"/>
            <ac:picMk id="4" creationId="{3B74CDC6-42DD-4AF9-9F37-3DD7672572AB}"/>
          </ac:picMkLst>
        </pc:picChg>
        <pc:picChg chg="add mod">
          <ac:chgData name="Tekle Pauzaite" userId="06f7e524-8501-4f81-9b2a-484f6f2c7061" providerId="ADAL" clId="{EBE1C779-1A9A-4B75-8FCF-B9A788BED485}" dt="2024-03-27T08:28:42.828" v="4" actId="1076"/>
          <ac:picMkLst>
            <pc:docMk/>
            <pc:sldMk cId="1632868039" sldId="256"/>
            <ac:picMk id="5" creationId="{0004F89F-DE9A-482A-BAA3-8B0E347FD1FA}"/>
          </ac:picMkLst>
        </pc:picChg>
        <pc:picChg chg="add mod">
          <ac:chgData name="Tekle Pauzaite" userId="06f7e524-8501-4f81-9b2a-484f6f2c7061" providerId="ADAL" clId="{EBE1C779-1A9A-4B75-8FCF-B9A788BED485}" dt="2024-03-27T08:28:42.828" v="4" actId="1076"/>
          <ac:picMkLst>
            <pc:docMk/>
            <pc:sldMk cId="1632868039" sldId="256"/>
            <ac:picMk id="6" creationId="{B36A8FFA-3B56-4A2D-8494-1B09609BDBF3}"/>
          </ac:picMkLst>
        </pc:picChg>
        <pc:picChg chg="add mod">
          <ac:chgData name="Tekle Pauzaite" userId="06f7e524-8501-4f81-9b2a-484f6f2c7061" providerId="ADAL" clId="{EBE1C779-1A9A-4B75-8FCF-B9A788BED485}" dt="2024-03-27T08:28:42.828" v="4" actId="1076"/>
          <ac:picMkLst>
            <pc:docMk/>
            <pc:sldMk cId="1632868039" sldId="256"/>
            <ac:picMk id="7" creationId="{0265E533-AC0B-43AC-B358-E986DDA6A9F7}"/>
          </ac:picMkLst>
        </pc:picChg>
        <pc:picChg chg="add mod">
          <ac:chgData name="Tekle Pauzaite" userId="06f7e524-8501-4f81-9b2a-484f6f2c7061" providerId="ADAL" clId="{EBE1C779-1A9A-4B75-8FCF-B9A788BED485}" dt="2024-03-27T08:28:42.828" v="4" actId="1076"/>
          <ac:picMkLst>
            <pc:docMk/>
            <pc:sldMk cId="1632868039" sldId="256"/>
            <ac:picMk id="35" creationId="{257FB1D7-F74D-45ED-A380-6C3D2AD6EE2A}"/>
          </ac:picMkLst>
        </pc:picChg>
        <pc:picChg chg="add mod modCrop">
          <ac:chgData name="Tekle Pauzaite" userId="06f7e524-8501-4f81-9b2a-484f6f2c7061" providerId="ADAL" clId="{EBE1C779-1A9A-4B75-8FCF-B9A788BED485}" dt="2024-03-27T08:30:40.739" v="44" actId="14100"/>
          <ac:picMkLst>
            <pc:docMk/>
            <pc:sldMk cId="1632868039" sldId="256"/>
            <ac:picMk id="36" creationId="{02E0372C-E09C-4B05-84F5-2611C05D9656}"/>
          </ac:picMkLst>
        </pc:picChg>
        <pc:picChg chg="add mod modCrop">
          <ac:chgData name="Tekle Pauzaite" userId="06f7e524-8501-4f81-9b2a-484f6f2c7061" providerId="ADAL" clId="{EBE1C779-1A9A-4B75-8FCF-B9A788BED485}" dt="2024-03-27T08:30:36.844" v="43" actId="1076"/>
          <ac:picMkLst>
            <pc:docMk/>
            <pc:sldMk cId="1632868039" sldId="256"/>
            <ac:picMk id="38" creationId="{BEA2C82E-DE1F-425B-BDAC-D67BD0818EDB}"/>
          </ac:picMkLst>
        </pc:picChg>
        <pc:picChg chg="add mod modCrop">
          <ac:chgData name="Tekle Pauzaite" userId="06f7e524-8501-4f81-9b2a-484f6f2c7061" providerId="ADAL" clId="{EBE1C779-1A9A-4B75-8FCF-B9A788BED485}" dt="2024-03-27T08:31:36.988" v="107" actId="1076"/>
          <ac:picMkLst>
            <pc:docMk/>
            <pc:sldMk cId="1632868039" sldId="256"/>
            <ac:picMk id="40" creationId="{D2D61EBF-DAF8-41CF-832D-BEA686C06D8C}"/>
          </ac:picMkLst>
        </pc:picChg>
        <pc:picChg chg="add mod modCrop">
          <ac:chgData name="Tekle Pauzaite" userId="06f7e524-8501-4f81-9b2a-484f6f2c7061" providerId="ADAL" clId="{EBE1C779-1A9A-4B75-8FCF-B9A788BED485}" dt="2024-03-27T08:32:13.067" v="123" actId="1076"/>
          <ac:picMkLst>
            <pc:docMk/>
            <pc:sldMk cId="1632868039" sldId="256"/>
            <ac:picMk id="42" creationId="{28E65FC5-E02C-4615-A2FE-5FC2D9287303}"/>
          </ac:picMkLst>
        </pc:picChg>
        <pc:picChg chg="add mod modCrop">
          <ac:chgData name="Tekle Pauzaite" userId="06f7e524-8501-4f81-9b2a-484f6f2c7061" providerId="ADAL" clId="{EBE1C779-1A9A-4B75-8FCF-B9A788BED485}" dt="2024-03-27T08:32:51.307" v="141" actId="1076"/>
          <ac:picMkLst>
            <pc:docMk/>
            <pc:sldMk cId="1632868039" sldId="256"/>
            <ac:picMk id="44" creationId="{9870B8B9-A65A-4B6A-9E7D-9A7E12BAD97B}"/>
          </ac:picMkLst>
        </pc:pic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11" creationId="{929A1B65-E0FD-48EC-A557-F32BE7C628DE}"/>
          </ac:cxnSpMkLst>
        </pc:cxn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13" creationId="{52C64D40-F8DD-48F6-AF9A-F86E826E7E67}"/>
          </ac:cxnSpMkLst>
        </pc:cxn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15" creationId="{903DD35D-355C-4E57-ACCF-4F7F97852938}"/>
          </ac:cxnSpMkLst>
        </pc:cxn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20" creationId="{51C9E951-00ED-4FD0-A9D4-AA433317D77F}"/>
          </ac:cxnSpMkLst>
        </pc:cxn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22" creationId="{114C3E89-088B-4D68-B8EB-EA299EDB105A}"/>
          </ac:cxnSpMkLst>
        </pc:cxn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30" creationId="{3D8C5117-6CC0-408A-B385-3CF50C880B4D}"/>
          </ac:cxnSpMkLst>
        </pc:cxnChg>
        <pc:cxnChg chg="add mod">
          <ac:chgData name="Tekle Pauzaite" userId="06f7e524-8501-4f81-9b2a-484f6f2c7061" providerId="ADAL" clId="{EBE1C779-1A9A-4B75-8FCF-B9A788BED485}" dt="2024-03-27T08:28:42.828" v="4" actId="1076"/>
          <ac:cxnSpMkLst>
            <pc:docMk/>
            <pc:sldMk cId="1632868039" sldId="256"/>
            <ac:cxnSpMk id="31" creationId="{C94F2D22-9C02-4A66-853A-64361D0CB3D0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741823-8323-43B2-AC59-9349972260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059511-F60A-43B8-8806-3B2B29B5B9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65AA5E-F86F-4B4B-BA3F-B00F7A333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623ED-88A6-4546-98FE-CE2DF30D7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E71F8D-1474-4AE9-A60C-7627A8ACF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5211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EB1B74-1D31-4920-94EC-94833B6CAE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484DDD-9D3A-4B56-9AFD-2B54278159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986FCA-432D-4C4A-B5FD-0100FA5A8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990D1F-DC83-41D2-B9DD-2336D693F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557AD0-AD54-44BD-A3FB-8737FE5F8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377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516FF5-5591-4A61-88D4-EE226F4C52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028691-D86A-480F-BAB3-4B087D0FD7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2FB08E-5939-4E71-9567-F1DB8FFE7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B88068-7FEE-4AA8-8278-1B05FDD7F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2A3D8F-1C25-455A-A105-97A4A8D81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207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F9446-04E3-4655-87F1-C72E2A8CDA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429470-1BFC-422E-99DC-BCFF77644D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174E6-0BEB-470C-A284-BAAAC3580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D5B5B-325A-4C2B-8DE8-C80A9A34D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39AD7B-A410-454E-BA86-00839742C3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7764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5A9D7-A298-4385-95A8-16A0832FB3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E1DC96-421E-40B5-88DB-F513B335B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A21677-3897-43E5-BC8E-FD84E1797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D9D07F-7F35-47F2-9E95-412A22D9F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682A2C-19B9-4794-93B3-624A2CDD6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588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87E360-8996-449C-80FB-355C1C207B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CD693B-1D98-43B6-BC84-1FD7DFC374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2D2B1F-2B5D-4CA3-8B85-4F33FDC535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9C6AFE-17C9-4549-B5E3-A0ED59B48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CC5DF0-255D-476B-88B2-EACA91FF4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E695AE-0E7F-4E3C-8266-1F34AD600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125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3DE3-393B-4F19-A316-0C3E82D403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9E9251-1BA7-4A29-8DC8-D32CD6FACE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CD370D-1B32-46D8-B02C-95D05FECB4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81D162-B8B2-46BC-B829-8CA535C899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39E042B-C38D-47E3-81C2-CC09096FBE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2EF342-9D2F-4664-A006-3EB79CF0B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6954074-80E0-422E-B379-34230D841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D0B6F5-43BF-4BEB-B1ED-72746FC55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95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D99EC-EA05-4718-9518-5583BB05D2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B4EC071-D009-4A92-9A44-0A18656E8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D4536A-1B42-4A2D-B875-7D67C5D9E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A75AF7-4965-4E7A-A006-5B9EB7B6E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895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F0EE2D-942C-4051-97D4-0B08EA122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04B275-3178-48D4-A64A-5DAC84A5E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F8EC15-21DC-4E2C-8094-FBAC62F14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9317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ECD6F2-F0C3-43D0-8F11-4F35B72574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6A883D-E1B9-4974-9799-E520CCEB2B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80B193-0D49-4BB0-85E7-1EDDEEA0BA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EB987B-CB8B-41AF-9F7A-5A867DDE7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177E1F-4D2D-40EC-80C5-349ECA87E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E67E8D-E8A1-4B12-AB31-E1CCD872C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9594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6600D-4912-4B5F-86B1-517509EC2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449A6DE-038C-4FB4-9014-DC118D74F7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DA0239-054D-4227-82D3-D55FC61467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C0974-6538-4890-872D-F51EF3ACA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2601B4-6803-4BE4-A18F-4DBB5E382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77847B-D789-4B6E-9117-4CD1E0991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031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7BA83A-8514-4223-AC09-59235866D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1228F7-37B7-4854-9207-4AE7962AD9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20AB38-4482-4197-93AD-4419931A19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DFC57-57B4-4143-9851-BB3AE87C420A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B88829-E527-4DA9-AECB-7E38D483B6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EAD897-5DFC-4190-A116-CD7DA4AC1D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9FBEE-B9AA-4231-9B5A-97C7FF9819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9745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microsoft.com/office/2007/relationships/hdphoto" Target="../media/hdphoto1.wdp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B74CDC6-42DD-4AF9-9F37-3DD7672572A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442" t="13750" r="22146" b="65833"/>
          <a:stretch/>
        </p:blipFill>
        <p:spPr>
          <a:xfrm rot="16200000">
            <a:off x="971673" y="1392821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004F89F-DE9A-482A-BAA3-8B0E347FD1F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75" t="14584" r="16571" b="65000"/>
          <a:stretch/>
        </p:blipFill>
        <p:spPr>
          <a:xfrm rot="16200000">
            <a:off x="971674" y="1063132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36A8FFA-3B56-4A2D-8494-1B09609BDBF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00" t="25860" r="19668" b="34419"/>
          <a:stretch/>
        </p:blipFill>
        <p:spPr>
          <a:xfrm rot="16200000">
            <a:off x="971673" y="733441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265E533-AC0B-43AC-B358-E986DDA6A9F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111" t="27902" r="29206" b="31696"/>
          <a:stretch/>
        </p:blipFill>
        <p:spPr>
          <a:xfrm rot="16200000">
            <a:off x="971673" y="1722510"/>
            <a:ext cx="295062" cy="9835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F3D270A-980A-4203-8193-EB80322C8C4D}"/>
              </a:ext>
            </a:extLst>
          </p:cNvPr>
          <p:cNvSpPr txBox="1"/>
          <p:nvPr/>
        </p:nvSpPr>
        <p:spPr>
          <a:xfrm>
            <a:off x="1610974" y="812128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6C3111-BB47-4A68-B086-17C8971BBCBB}"/>
              </a:ext>
            </a:extLst>
          </p:cNvPr>
          <p:cNvSpPr txBox="1"/>
          <p:nvPr/>
        </p:nvSpPr>
        <p:spPr>
          <a:xfrm>
            <a:off x="1610974" y="1470814"/>
            <a:ext cx="49139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68886A-46AF-4EF6-89EC-13AB869E2DD6}"/>
              </a:ext>
            </a:extLst>
          </p:cNvPr>
          <p:cNvSpPr txBox="1"/>
          <p:nvPr/>
        </p:nvSpPr>
        <p:spPr>
          <a:xfrm>
            <a:off x="226144" y="788336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29A1B65-E0FD-48EC-A557-F32BE7C628DE}"/>
              </a:ext>
            </a:extLst>
          </p:cNvPr>
          <p:cNvCxnSpPr>
            <a:cxnSpLocks/>
          </p:cNvCxnSpPr>
          <p:nvPr/>
        </p:nvCxnSpPr>
        <p:spPr>
          <a:xfrm>
            <a:off x="533276" y="876881"/>
            <a:ext cx="678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F82DD0FB-1D3F-4FDB-B64A-1DDD42B08CBD}"/>
              </a:ext>
            </a:extLst>
          </p:cNvPr>
          <p:cNvSpPr txBox="1"/>
          <p:nvPr/>
        </p:nvSpPr>
        <p:spPr>
          <a:xfrm>
            <a:off x="290263" y="1147980"/>
            <a:ext cx="3129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2C64D40-F8DD-48F6-AF9A-F86E826E7E67}"/>
              </a:ext>
            </a:extLst>
          </p:cNvPr>
          <p:cNvCxnSpPr>
            <a:cxnSpLocks/>
          </p:cNvCxnSpPr>
          <p:nvPr/>
        </p:nvCxnSpPr>
        <p:spPr>
          <a:xfrm>
            <a:off x="533276" y="1260339"/>
            <a:ext cx="678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C310176-72F2-4E04-BE9D-BF305B40E334}"/>
              </a:ext>
            </a:extLst>
          </p:cNvPr>
          <p:cNvSpPr txBox="1"/>
          <p:nvPr/>
        </p:nvSpPr>
        <p:spPr>
          <a:xfrm>
            <a:off x="290263" y="1442026"/>
            <a:ext cx="3129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903DD35D-355C-4E57-ACCF-4F7F97852938}"/>
              </a:ext>
            </a:extLst>
          </p:cNvPr>
          <p:cNvCxnSpPr>
            <a:cxnSpLocks/>
          </p:cNvCxnSpPr>
          <p:nvPr/>
        </p:nvCxnSpPr>
        <p:spPr>
          <a:xfrm>
            <a:off x="533276" y="1554386"/>
            <a:ext cx="678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10367B89-794E-4D87-A454-F5DE3FCF6CFD}"/>
              </a:ext>
            </a:extLst>
          </p:cNvPr>
          <p:cNvSpPr txBox="1"/>
          <p:nvPr/>
        </p:nvSpPr>
        <p:spPr>
          <a:xfrm>
            <a:off x="1610974" y="1141124"/>
            <a:ext cx="454962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C7FBF1D-5109-4DCF-9225-39DD5293A0CB}"/>
              </a:ext>
            </a:extLst>
          </p:cNvPr>
          <p:cNvSpPr txBox="1"/>
          <p:nvPr/>
        </p:nvSpPr>
        <p:spPr>
          <a:xfrm>
            <a:off x="1610974" y="2132088"/>
            <a:ext cx="49576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4D7696-B38E-42BB-8311-EAA213306EF8}"/>
              </a:ext>
            </a:extLst>
          </p:cNvPr>
          <p:cNvSpPr txBox="1"/>
          <p:nvPr/>
        </p:nvSpPr>
        <p:spPr>
          <a:xfrm>
            <a:off x="1610628" y="1800505"/>
            <a:ext cx="37189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A401C27-2E21-4429-8F77-89D9E17B0D44}"/>
              </a:ext>
            </a:extLst>
          </p:cNvPr>
          <p:cNvSpPr txBox="1"/>
          <p:nvPr/>
        </p:nvSpPr>
        <p:spPr>
          <a:xfrm>
            <a:off x="290263" y="1740426"/>
            <a:ext cx="3129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1C9E951-00ED-4FD0-A9D4-AA433317D77F}"/>
              </a:ext>
            </a:extLst>
          </p:cNvPr>
          <p:cNvCxnSpPr>
            <a:cxnSpLocks/>
          </p:cNvCxnSpPr>
          <p:nvPr/>
        </p:nvCxnSpPr>
        <p:spPr>
          <a:xfrm>
            <a:off x="533276" y="1852786"/>
            <a:ext cx="678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83609F11-7ABD-439F-A17F-F07B837A7355}"/>
              </a:ext>
            </a:extLst>
          </p:cNvPr>
          <p:cNvSpPr txBox="1"/>
          <p:nvPr/>
        </p:nvSpPr>
        <p:spPr>
          <a:xfrm>
            <a:off x="290263" y="2034472"/>
            <a:ext cx="3129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14C3E89-088B-4D68-B8EB-EA299EDB105A}"/>
              </a:ext>
            </a:extLst>
          </p:cNvPr>
          <p:cNvCxnSpPr>
            <a:cxnSpLocks/>
          </p:cNvCxnSpPr>
          <p:nvPr/>
        </p:nvCxnSpPr>
        <p:spPr>
          <a:xfrm>
            <a:off x="533276" y="2146833"/>
            <a:ext cx="678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3C04188A-320F-4CE9-8743-9C74906EFD0C}"/>
              </a:ext>
            </a:extLst>
          </p:cNvPr>
          <p:cNvSpPr txBox="1"/>
          <p:nvPr/>
        </p:nvSpPr>
        <p:spPr>
          <a:xfrm rot="18900000">
            <a:off x="572727" y="443212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8B06F9D-81AE-4B47-9372-1C67A1465A0D}"/>
              </a:ext>
            </a:extLst>
          </p:cNvPr>
          <p:cNvSpPr txBox="1"/>
          <p:nvPr/>
        </p:nvSpPr>
        <p:spPr>
          <a:xfrm rot="18900000">
            <a:off x="734055" y="45792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4011465-6E14-46EB-A409-091BF4C9415F}"/>
              </a:ext>
            </a:extLst>
          </p:cNvPr>
          <p:cNvSpPr txBox="1"/>
          <p:nvPr/>
        </p:nvSpPr>
        <p:spPr>
          <a:xfrm rot="18900000">
            <a:off x="867581" y="44514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2F764B9-1094-42F5-84AA-0C3AA1EDE949}"/>
              </a:ext>
            </a:extLst>
          </p:cNvPr>
          <p:cNvSpPr txBox="1"/>
          <p:nvPr/>
        </p:nvSpPr>
        <p:spPr>
          <a:xfrm rot="18900000">
            <a:off x="1016547" y="443212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7B2B951-41F4-4722-818E-D059C1244D92}"/>
              </a:ext>
            </a:extLst>
          </p:cNvPr>
          <p:cNvSpPr txBox="1"/>
          <p:nvPr/>
        </p:nvSpPr>
        <p:spPr>
          <a:xfrm rot="18900000">
            <a:off x="1177876" y="45792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BE07845-B0F1-4BF8-A45F-A169AD0402D6}"/>
              </a:ext>
            </a:extLst>
          </p:cNvPr>
          <p:cNvSpPr txBox="1"/>
          <p:nvPr/>
        </p:nvSpPr>
        <p:spPr>
          <a:xfrm rot="18900000">
            <a:off x="1311402" y="445147"/>
            <a:ext cx="5116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446AF7A-A132-4852-8550-A467E8A4A384}"/>
              </a:ext>
            </a:extLst>
          </p:cNvPr>
          <p:cNvSpPr txBox="1"/>
          <p:nvPr/>
        </p:nvSpPr>
        <p:spPr>
          <a:xfrm>
            <a:off x="1610974" y="559255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gRNA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D8C5117-6CC0-408A-B385-3CF50C880B4D}"/>
              </a:ext>
            </a:extLst>
          </p:cNvPr>
          <p:cNvCxnSpPr/>
          <p:nvPr/>
        </p:nvCxnSpPr>
        <p:spPr>
          <a:xfrm>
            <a:off x="697328" y="372514"/>
            <a:ext cx="3916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94F2D22-9C02-4A66-853A-64361D0CB3D0}"/>
              </a:ext>
            </a:extLst>
          </p:cNvPr>
          <p:cNvCxnSpPr/>
          <p:nvPr/>
        </p:nvCxnSpPr>
        <p:spPr>
          <a:xfrm>
            <a:off x="1161664" y="372514"/>
            <a:ext cx="39162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243F1AC9-995B-4D5D-B356-C56CF34E085B}"/>
              </a:ext>
            </a:extLst>
          </p:cNvPr>
          <p:cNvSpPr txBox="1"/>
          <p:nvPr/>
        </p:nvSpPr>
        <p:spPr>
          <a:xfrm>
            <a:off x="997357" y="175702"/>
            <a:ext cx="125386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Roxadustat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(100 µM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9861E2F-6EB2-43AB-A800-5D3E1BB69709}"/>
              </a:ext>
            </a:extLst>
          </p:cNvPr>
          <p:cNvSpPr txBox="1"/>
          <p:nvPr/>
        </p:nvSpPr>
        <p:spPr>
          <a:xfrm>
            <a:off x="625093" y="175702"/>
            <a:ext cx="482650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5E5A4B-343F-4F23-9AE5-EF668683AC27}"/>
              </a:ext>
            </a:extLst>
          </p:cNvPr>
          <p:cNvSpPr txBox="1"/>
          <p:nvPr/>
        </p:nvSpPr>
        <p:spPr>
          <a:xfrm>
            <a:off x="639766" y="2391054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ells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57FB1D7-F74D-45ED-A380-6C3D2AD6EE2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618" t="21683" r="57121" b="38806"/>
          <a:stretch/>
        </p:blipFill>
        <p:spPr>
          <a:xfrm rot="16200000">
            <a:off x="974790" y="398818"/>
            <a:ext cx="295062" cy="9835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02E0372C-E09C-4B05-84F5-2611C05D965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7" t="221" r="143" b="574"/>
          <a:stretch/>
        </p:blipFill>
        <p:spPr>
          <a:xfrm rot="16200000">
            <a:off x="1792181" y="1144115"/>
            <a:ext cx="3330796" cy="13939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DE552C32-B466-4C33-B8FF-E07D3446BFB0}"/>
              </a:ext>
            </a:extLst>
          </p:cNvPr>
          <p:cNvSpPr/>
          <p:nvPr/>
        </p:nvSpPr>
        <p:spPr>
          <a:xfrm>
            <a:off x="3049476" y="2127885"/>
            <a:ext cx="585899" cy="1111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EA2C82E-DE1F-425B-BDAC-D67BD0818ED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2" t="-1689" r="53" b="2314"/>
          <a:stretch/>
        </p:blipFill>
        <p:spPr>
          <a:xfrm rot="16200000">
            <a:off x="3441679" y="1012465"/>
            <a:ext cx="3307425" cy="16806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7EEBCB5F-58BE-45F8-A3F3-9CF883B23EEB}"/>
              </a:ext>
            </a:extLst>
          </p:cNvPr>
          <p:cNvSpPr/>
          <p:nvPr/>
        </p:nvSpPr>
        <p:spPr>
          <a:xfrm>
            <a:off x="4731592" y="882031"/>
            <a:ext cx="644489" cy="147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D2D61EBF-DAF8-41CF-832D-BEA686C06D8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9" t="-419" r="22" b="202"/>
          <a:stretch/>
        </p:blipFill>
        <p:spPr>
          <a:xfrm rot="16200000">
            <a:off x="6365647" y="-130354"/>
            <a:ext cx="2638715" cy="32975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Rectangle 40">
            <a:extLst>
              <a:ext uri="{FF2B5EF4-FFF2-40B4-BE49-F238E27FC236}">
                <a16:creationId xmlns:a16="http://schemas.microsoft.com/office/drawing/2014/main" id="{88611FE3-3DFC-434B-A100-6D2AA6B84E02}"/>
              </a:ext>
            </a:extLst>
          </p:cNvPr>
          <p:cNvSpPr/>
          <p:nvPr/>
        </p:nvSpPr>
        <p:spPr>
          <a:xfrm>
            <a:off x="6552772" y="657032"/>
            <a:ext cx="644489" cy="147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28E65FC5-E02C-4615-A2FE-5FC2D928730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94" t="250" r="812" b="97"/>
          <a:stretch/>
        </p:blipFill>
        <p:spPr>
          <a:xfrm rot="16200000">
            <a:off x="732013" y="3429065"/>
            <a:ext cx="2395376" cy="32788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EFB77EA1-F51F-4876-AC46-ED5E6BBA6D88}"/>
              </a:ext>
            </a:extLst>
          </p:cNvPr>
          <p:cNvSpPr/>
          <p:nvPr/>
        </p:nvSpPr>
        <p:spPr>
          <a:xfrm>
            <a:off x="766784" y="4411859"/>
            <a:ext cx="644489" cy="147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9870B8B9-A65A-4B6A-9E7D-9A7E12BAD97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5" t="-732" r="75" b="-104"/>
          <a:stretch/>
        </p:blipFill>
        <p:spPr>
          <a:xfrm rot="16200000">
            <a:off x="3135279" y="4331201"/>
            <a:ext cx="3025586" cy="16766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Rectangle 44">
            <a:extLst>
              <a:ext uri="{FF2B5EF4-FFF2-40B4-BE49-F238E27FC236}">
                <a16:creationId xmlns:a16="http://schemas.microsoft.com/office/drawing/2014/main" id="{0D0C5E06-7EFF-4C71-8CCF-DFA00E097F5E}"/>
              </a:ext>
            </a:extLst>
          </p:cNvPr>
          <p:cNvSpPr/>
          <p:nvPr/>
        </p:nvSpPr>
        <p:spPr>
          <a:xfrm>
            <a:off x="4254596" y="4559767"/>
            <a:ext cx="708938" cy="1479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C6206A9-AA02-4FEB-8EE0-4B24975E8ED0}"/>
              </a:ext>
            </a:extLst>
          </p:cNvPr>
          <p:cNvSpPr txBox="1"/>
          <p:nvPr/>
        </p:nvSpPr>
        <p:spPr>
          <a:xfrm>
            <a:off x="3635375" y="2078523"/>
            <a:ext cx="50013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1D95358-D4F1-4BB3-B7F9-DC3D0030FBC6}"/>
              </a:ext>
            </a:extLst>
          </p:cNvPr>
          <p:cNvSpPr txBox="1"/>
          <p:nvPr/>
        </p:nvSpPr>
        <p:spPr>
          <a:xfrm>
            <a:off x="4843961" y="1013486"/>
            <a:ext cx="454962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E405721-94ED-494E-AB5D-89B6426B3CDB}"/>
              </a:ext>
            </a:extLst>
          </p:cNvPr>
          <p:cNvSpPr txBox="1"/>
          <p:nvPr/>
        </p:nvSpPr>
        <p:spPr>
          <a:xfrm>
            <a:off x="6629319" y="442117"/>
            <a:ext cx="491393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9B85F9-D6CB-4FA7-A4A1-7CC804FC9BD5}"/>
              </a:ext>
            </a:extLst>
          </p:cNvPr>
          <p:cNvSpPr txBox="1"/>
          <p:nvPr/>
        </p:nvSpPr>
        <p:spPr>
          <a:xfrm>
            <a:off x="406887" y="4371884"/>
            <a:ext cx="371897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36E4465-1351-4A22-94FD-DC0FECE635C7}"/>
              </a:ext>
            </a:extLst>
          </p:cNvPr>
          <p:cNvSpPr txBox="1"/>
          <p:nvPr/>
        </p:nvSpPr>
        <p:spPr>
          <a:xfrm>
            <a:off x="4963534" y="4528797"/>
            <a:ext cx="495765" cy="2098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1632868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9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3-27T08:28:29Z</dcterms:created>
  <dcterms:modified xsi:type="dcterms:W3CDTF">2024-03-27T08:33:24Z</dcterms:modified>
</cp:coreProperties>
</file>